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141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6775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4379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6902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9171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8539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5054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8557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521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3502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5149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4780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11164-885F-4AF9-803E-C0ADB87F5D48}" type="datetimeFigureOut">
              <a:rPr lang="it-IT" smtClean="0"/>
              <a:t>29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F8E75-AB6F-46F6-8223-420597FAFD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8244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93000" y="467221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114303" y="131886"/>
            <a:ext cx="78188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ublicly available sequences of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uignardia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dwellii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panel A) and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sino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elina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panel B)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000" y="744220"/>
            <a:ext cx="9720000" cy="6031734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484558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93000" y="34194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000" y="636530"/>
            <a:ext cx="9720000" cy="6031732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556491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25</Words>
  <Application>Microsoft Office PowerPoint</Application>
  <PresentationFormat>A4 (21x29,7 cm)</PresentationFormat>
  <Paragraphs>3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</vt:vector>
  </TitlesOfParts>
  <Company>F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ilvia Vezzulli</dc:creator>
  <cp:lastModifiedBy>Chiara</cp:lastModifiedBy>
  <cp:revision>9</cp:revision>
  <dcterms:created xsi:type="dcterms:W3CDTF">2019-06-13T13:37:59Z</dcterms:created>
  <dcterms:modified xsi:type="dcterms:W3CDTF">2019-08-29T06:50:42Z</dcterms:modified>
</cp:coreProperties>
</file>